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47"/>
    <a:srgbClr val="0092F7"/>
    <a:srgbClr val="003969"/>
    <a:srgbClr val="65AA00"/>
    <a:srgbClr val="AA0065"/>
    <a:srgbClr val="96005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C77F1A-8205-4B4C-B3A4-7A54407120DE}" v="1" dt="2025-10-15T12:26:07.5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5" d="100"/>
          <a:sy n="55" d="100"/>
        </p:scale>
        <p:origin x="93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TW" dirty="0"/>
              <a:t>Mutation</a:t>
            </a:r>
            <a:r>
              <a:rPr lang="en-US" altLang="zh-TW" baseline="0" dirty="0"/>
              <a:t> Variants in </a:t>
            </a:r>
          </a:p>
          <a:p>
            <a:pPr>
              <a:defRPr/>
            </a:pPr>
            <a:r>
              <a:rPr lang="en-US" altLang="zh-TW" baseline="0" dirty="0"/>
              <a:t>Transplant recipients</a:t>
            </a:r>
            <a:endParaRPr lang="en-US" altLang="zh-TW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43C-4514-933C-A86830526C3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43C-4514-933C-A86830526C3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43C-4514-933C-A86830526C36}"/>
              </c:ext>
            </c:extLst>
          </c:dPt>
          <c:dLbls>
            <c:dLbl>
              <c:idx val="0"/>
              <c:layout>
                <c:manualLayout>
                  <c:x val="-8.1113079615048114E-2"/>
                  <c:y val="0.14522674249052198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43C-4514-933C-A86830526C36}"/>
                </c:ext>
              </c:extLst>
            </c:dLbl>
            <c:dLbl>
              <c:idx val="1"/>
              <c:layout>
                <c:manualLayout>
                  <c:x val="0.10380183727034131"/>
                  <c:y val="-0.23097586759988334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43C-4514-933C-A86830526C36}"/>
                </c:ext>
              </c:extLst>
            </c:dLbl>
            <c:dLbl>
              <c:idx val="2"/>
              <c:layout>
                <c:manualLayout>
                  <c:x val="5.6579615048119036E-2"/>
                  <c:y val="0.13838400408282298"/>
                </c:manualLayout>
              </c:layout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43C-4514-933C-A86830526C3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zh-HK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1!$A$2:$A$4</c:f>
              <c:strCache>
                <c:ptCount val="3"/>
                <c:pt idx="0">
                  <c:v>RMND1 (c.713A&gt;G)</c:v>
                </c:pt>
                <c:pt idx="1">
                  <c:v>MELAS/ MIDD (m.3243A&gt;G)</c:v>
                </c:pt>
                <c:pt idx="2">
                  <c:v>Others</c:v>
                </c:pt>
              </c:strCache>
            </c:strRef>
          </c:cat>
          <c:val>
            <c:numRef>
              <c:f>Sheet1!$B$2:$B$4</c:f>
              <c:numCache>
                <c:formatCode>0%</c:formatCode>
                <c:ptCount val="3"/>
                <c:pt idx="0">
                  <c:v>0.21739130434782608</c:v>
                </c:pt>
                <c:pt idx="1">
                  <c:v>0.67391304347826086</c:v>
                </c:pt>
                <c:pt idx="2">
                  <c:v>0.10869565217391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43C-4514-933C-A86830526C36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HK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zh-HK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svg"/><Relationship Id="rId18" Type="http://schemas.openxmlformats.org/officeDocument/2006/relationships/image" Target="../media/image17.svg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12" Type="http://schemas.openxmlformats.org/officeDocument/2006/relationships/image" Target="../media/image12.png"/><Relationship Id="rId17" Type="http://schemas.openxmlformats.org/officeDocument/2006/relationships/image" Target="../media/image16.png"/><Relationship Id="rId2" Type="http://schemas.openxmlformats.org/officeDocument/2006/relationships/image" Target="../media/image2.png"/><Relationship Id="rId16" Type="http://schemas.openxmlformats.org/officeDocument/2006/relationships/image" Target="../media/image15.svg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6.png"/><Relationship Id="rId11" Type="http://schemas.openxmlformats.org/officeDocument/2006/relationships/image" Target="../media/image11.svg"/><Relationship Id="rId5" Type="http://schemas.openxmlformats.org/officeDocument/2006/relationships/image" Target="../media/image5.svg"/><Relationship Id="rId15" Type="http://schemas.openxmlformats.org/officeDocument/2006/relationships/image" Target="../media/image14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svg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833151AA-46DA-F3CD-E218-C679B336C057}"/>
              </a:ext>
            </a:extLst>
          </p:cNvPr>
          <p:cNvSpPr/>
          <p:nvPr/>
        </p:nvSpPr>
        <p:spPr>
          <a:xfrm>
            <a:off x="6230112" y="1617785"/>
            <a:ext cx="5961888" cy="406113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HK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61B3757-536B-4B9D-AB86-DAB6DD8EBF4A}"/>
              </a:ext>
            </a:extLst>
          </p:cNvPr>
          <p:cNvSpPr/>
          <p:nvPr/>
        </p:nvSpPr>
        <p:spPr>
          <a:xfrm>
            <a:off x="6230112" y="3927818"/>
            <a:ext cx="5961888" cy="1759138"/>
          </a:xfrm>
          <a:prstGeom prst="rect">
            <a:avLst/>
          </a:prstGeom>
          <a:solidFill>
            <a:srgbClr val="E99847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HK" altLang="en-US"/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HK" sz="2800" b="1" dirty="0">
                <a:solidFill>
                  <a:schemeClr val="bg1"/>
                </a:solidFill>
              </a:rPr>
              <a:t>Kidney transplantation in mitochondrial diseases: </a:t>
            </a:r>
          </a:p>
          <a:p>
            <a:r>
              <a:rPr lang="en-HK" sz="2800" b="1" dirty="0">
                <a:solidFill>
                  <a:schemeClr val="bg1"/>
                </a:solidFill>
              </a:rPr>
              <a:t>a systematic review</a:t>
            </a:r>
            <a:endParaRPr lang="en-HK" sz="2800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407E4-009E-18F9-F577-012EBA0C2DCD}"/>
              </a:ext>
            </a:extLst>
          </p:cNvPr>
          <p:cNvSpPr txBox="1"/>
          <p:nvPr/>
        </p:nvSpPr>
        <p:spPr>
          <a:xfrm>
            <a:off x="123432" y="172453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ong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Kidney transplantation is a viable option of KRT in patients with mitochondrial cytopathies. Multi-disciplinary assessment and peri-op planning are crucial to success. Further studies are required to better delineate long term outcomes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FF53A7C-453A-35DD-78D7-DE799C46BA4F}"/>
              </a:ext>
            </a:extLst>
          </p:cNvPr>
          <p:cNvSpPr/>
          <p:nvPr/>
        </p:nvSpPr>
        <p:spPr>
          <a:xfrm>
            <a:off x="2335195" y="1553431"/>
            <a:ext cx="3760805" cy="707456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dirty="0">
                <a:solidFill>
                  <a:srgbClr val="296DC0"/>
                </a:solidFill>
              </a:rPr>
              <a:t>2 retrospective cohorts &amp; 16 case series/ reports</a:t>
            </a:r>
          </a:p>
        </p:txBody>
      </p:sp>
      <p:pic>
        <p:nvPicPr>
          <p:cNvPr id="22" name="Graphic 21" descr="Kidneys outline">
            <a:extLst>
              <a:ext uri="{FF2B5EF4-FFF2-40B4-BE49-F238E27FC236}">
                <a16:creationId xmlns:a16="http://schemas.microsoft.com/office/drawing/2014/main" id="{3DCD17F7-6530-CC9E-8D67-174F2E57E4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0916160" y="2025834"/>
            <a:ext cx="1013890" cy="1013890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EF16A012-774C-4692-979A-1C67439A737B}"/>
              </a:ext>
            </a:extLst>
          </p:cNvPr>
          <p:cNvGrpSpPr/>
          <p:nvPr/>
        </p:nvGrpSpPr>
        <p:grpSpPr>
          <a:xfrm>
            <a:off x="72581" y="2032122"/>
            <a:ext cx="1442184" cy="1554273"/>
            <a:chOff x="325260" y="2583881"/>
            <a:chExt cx="2705159" cy="2765511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7E85A1D1-4802-B926-3FFC-7620AC30B7BB}"/>
                </a:ext>
              </a:extLst>
            </p:cNvPr>
            <p:cNvGrpSpPr/>
            <p:nvPr/>
          </p:nvGrpSpPr>
          <p:grpSpPr>
            <a:xfrm>
              <a:off x="503209" y="2583881"/>
              <a:ext cx="2527210" cy="1149608"/>
              <a:chOff x="645694" y="2810262"/>
              <a:chExt cx="2527210" cy="1149608"/>
            </a:xfrm>
          </p:grpSpPr>
          <p:pic>
            <p:nvPicPr>
              <p:cNvPr id="16" name="Graphic 15" descr="Baby crawling outline">
                <a:extLst>
                  <a:ext uri="{FF2B5EF4-FFF2-40B4-BE49-F238E27FC236}">
                    <a16:creationId xmlns:a16="http://schemas.microsoft.com/office/drawing/2014/main" id="{4ECF442F-2977-74E5-331F-6E40F3ED6F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tretch>
                <a:fillRect/>
              </a:stretch>
            </p:blipFill>
            <p:spPr>
              <a:xfrm>
                <a:off x="645694" y="2810262"/>
                <a:ext cx="914400" cy="914400"/>
              </a:xfrm>
              <a:prstGeom prst="rect">
                <a:avLst/>
              </a:prstGeom>
            </p:spPr>
          </p:pic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A7F21A5-C477-7E44-3A50-3CAC16BD20B0}"/>
                  </a:ext>
                </a:extLst>
              </p:cNvPr>
              <p:cNvSpPr txBox="1"/>
              <p:nvPr/>
            </p:nvSpPr>
            <p:spPr>
              <a:xfrm>
                <a:off x="691139" y="3590538"/>
                <a:ext cx="24817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solidFill>
                      <a:srgbClr val="296DC0"/>
                    </a:solidFill>
                  </a:rPr>
                  <a:t>n=15</a:t>
                </a: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83EFFD10-0163-4AE3-EBA2-C127A056A42D}"/>
                </a:ext>
              </a:extLst>
            </p:cNvPr>
            <p:cNvGrpSpPr/>
            <p:nvPr/>
          </p:nvGrpSpPr>
          <p:grpSpPr>
            <a:xfrm>
              <a:off x="325260" y="3951606"/>
              <a:ext cx="2646201" cy="1397786"/>
              <a:chOff x="436971" y="4032675"/>
              <a:chExt cx="2725799" cy="1511537"/>
            </a:xfrm>
          </p:grpSpPr>
          <p:pic>
            <p:nvPicPr>
              <p:cNvPr id="18" name="Graphic 17" descr="Man outline">
                <a:extLst>
                  <a:ext uri="{FF2B5EF4-FFF2-40B4-BE49-F238E27FC236}">
                    <a16:creationId xmlns:a16="http://schemas.microsoft.com/office/drawing/2014/main" id="{F5060EFF-6910-5264-1406-BEA08C7CBE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436971" y="4032675"/>
                <a:ext cx="1142205" cy="1142205"/>
              </a:xfrm>
              <a:prstGeom prst="rect">
                <a:avLst/>
              </a:prstGeom>
            </p:spPr>
          </p:pic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5708D48-7D29-1C56-DF2F-E1A238CC97E3}"/>
                  </a:ext>
                </a:extLst>
              </p:cNvPr>
              <p:cNvSpPr txBox="1"/>
              <p:nvPr/>
            </p:nvSpPr>
            <p:spPr>
              <a:xfrm>
                <a:off x="681005" y="5174880"/>
                <a:ext cx="248176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dirty="0">
                    <a:solidFill>
                      <a:srgbClr val="296DC0"/>
                    </a:solidFill>
                  </a:rPr>
                  <a:t>n=31</a:t>
                </a:r>
              </a:p>
            </p:txBody>
          </p:sp>
        </p:grpSp>
      </p:grpSp>
      <p:pic>
        <p:nvPicPr>
          <p:cNvPr id="41" name="Graphic 40" descr="Gravestone outline">
            <a:extLst>
              <a:ext uri="{FF2B5EF4-FFF2-40B4-BE49-F238E27FC236}">
                <a16:creationId xmlns:a16="http://schemas.microsoft.com/office/drawing/2014/main" id="{429E7AC3-4E36-7DAE-3EC5-3A2E108F4C2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9495767" y="2151364"/>
            <a:ext cx="789338" cy="789338"/>
          </a:xfrm>
          <a:prstGeom prst="rect">
            <a:avLst/>
          </a:prstGeom>
        </p:spPr>
      </p:pic>
      <p:pic>
        <p:nvPicPr>
          <p:cNvPr id="12" name="Graphic 11" descr="Daily calendar outline">
            <a:extLst>
              <a:ext uri="{FF2B5EF4-FFF2-40B4-BE49-F238E27FC236}">
                <a16:creationId xmlns:a16="http://schemas.microsoft.com/office/drawing/2014/main" id="{53F3B79A-AD39-43A7-6E08-DCF075921C7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8040210" y="2106010"/>
            <a:ext cx="914400" cy="914400"/>
          </a:xfrm>
          <a:prstGeom prst="rect">
            <a:avLst/>
          </a:prstGeom>
        </p:spPr>
      </p:pic>
      <p:pic>
        <p:nvPicPr>
          <p:cNvPr id="7" name="Graphic 6" descr="DNA with solid fill">
            <a:extLst>
              <a:ext uri="{FF2B5EF4-FFF2-40B4-BE49-F238E27FC236}">
                <a16:creationId xmlns:a16="http://schemas.microsoft.com/office/drawing/2014/main" id="{9E91B48E-95C1-4E91-B918-2753C8D0696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3"/>
              </a:ext>
            </a:extLst>
          </a:blip>
          <a:stretch>
            <a:fillRect/>
          </a:stretch>
        </p:blipFill>
        <p:spPr>
          <a:xfrm>
            <a:off x="717726" y="3027589"/>
            <a:ext cx="690388" cy="1173502"/>
          </a:xfrm>
          <a:prstGeom prst="rect">
            <a:avLst/>
          </a:prstGeom>
        </p:spPr>
      </p:pic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849E4B0E-E3C3-4189-BBFE-B0A2622A74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6707696"/>
              </p:ext>
            </p:extLst>
          </p:nvPr>
        </p:nvGraphicFramePr>
        <p:xfrm>
          <a:off x="72581" y="2093867"/>
          <a:ext cx="5147432" cy="3535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D471B8BC-529B-4C95-A378-B7C30E3070EF}"/>
              </a:ext>
            </a:extLst>
          </p:cNvPr>
          <p:cNvSpPr/>
          <p:nvPr/>
        </p:nvSpPr>
        <p:spPr>
          <a:xfrm>
            <a:off x="3932335" y="4140881"/>
            <a:ext cx="2163665" cy="1140193"/>
          </a:xfrm>
          <a:prstGeom prst="roundRect">
            <a:avLst/>
          </a:prstGeom>
          <a:solidFill>
            <a:srgbClr val="E9984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HK" sz="1300" dirty="0"/>
              <a:t>Age at diagnosis: 0.2-42</a:t>
            </a:r>
          </a:p>
          <a:p>
            <a:r>
              <a:rPr lang="en-US" altLang="zh-HK" sz="1300" dirty="0"/>
              <a:t>Median: 7</a:t>
            </a:r>
          </a:p>
          <a:p>
            <a:r>
              <a:rPr lang="en-US" altLang="zh-HK" sz="1300" dirty="0"/>
              <a:t>Type 4 RTA : 40%</a:t>
            </a:r>
          </a:p>
          <a:p>
            <a:r>
              <a:rPr lang="en-US" altLang="zh-HK" sz="1300" dirty="0"/>
              <a:t>CKD: 30%</a:t>
            </a:r>
          </a:p>
          <a:p>
            <a:r>
              <a:rPr lang="en-US" altLang="zh-HK" sz="1300" dirty="0"/>
              <a:t>KF: 20%</a:t>
            </a:r>
            <a:endParaRPr lang="zh-HK" altLang="en-US" sz="1300" dirty="0"/>
          </a:p>
        </p:txBody>
      </p:sp>
      <p:sp>
        <p:nvSpPr>
          <p:cNvPr id="28" name="Rectangle: Rounded Corners 27">
            <a:extLst>
              <a:ext uri="{FF2B5EF4-FFF2-40B4-BE49-F238E27FC236}">
                <a16:creationId xmlns:a16="http://schemas.microsoft.com/office/drawing/2014/main" id="{1416A625-7829-4025-9127-C08631182154}"/>
              </a:ext>
            </a:extLst>
          </p:cNvPr>
          <p:cNvSpPr/>
          <p:nvPr/>
        </p:nvSpPr>
        <p:spPr>
          <a:xfrm>
            <a:off x="3932335" y="2427906"/>
            <a:ext cx="2163665" cy="1140193"/>
          </a:xfrm>
          <a:prstGeom prst="round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HK" sz="1300" dirty="0"/>
              <a:t>Age at diagnosis: 25-56</a:t>
            </a:r>
          </a:p>
          <a:p>
            <a:r>
              <a:rPr lang="en-US" altLang="zh-HK" sz="1300" dirty="0"/>
              <a:t>Median 36</a:t>
            </a:r>
          </a:p>
          <a:p>
            <a:r>
              <a:rPr lang="en-US" altLang="zh-HK" sz="1300"/>
              <a:t>Type 4 RTA </a:t>
            </a:r>
            <a:r>
              <a:rPr lang="en-US" altLang="zh-HK" sz="1300" dirty="0"/>
              <a:t>: 68%</a:t>
            </a:r>
          </a:p>
          <a:p>
            <a:r>
              <a:rPr lang="en-US" altLang="zh-HK" sz="1300" dirty="0"/>
              <a:t>CKD: 29%</a:t>
            </a:r>
          </a:p>
          <a:p>
            <a:r>
              <a:rPr lang="en-US" altLang="zh-HK" sz="1300" dirty="0"/>
              <a:t>KF: 23%</a:t>
            </a:r>
            <a:endParaRPr lang="zh-HK" altLang="en-US" sz="1300" dirty="0"/>
          </a:p>
        </p:txBody>
      </p:sp>
      <p:pic>
        <p:nvPicPr>
          <p:cNvPr id="25" name="Graphic 24" descr="Warning with solid fill">
            <a:extLst>
              <a:ext uri="{FF2B5EF4-FFF2-40B4-BE49-F238E27FC236}">
                <a16:creationId xmlns:a16="http://schemas.microsoft.com/office/drawing/2014/main" id="{318DF4B6-4B07-47EC-9FFA-4885832AC530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1512305" y="2532779"/>
            <a:ext cx="457200" cy="457200"/>
          </a:xfrm>
          <a:prstGeom prst="rect">
            <a:avLst/>
          </a:prstGeom>
        </p:spPr>
      </p:pic>
      <p:pic>
        <p:nvPicPr>
          <p:cNvPr id="33" name="Graphic 32" descr="Kidneys outline">
            <a:extLst>
              <a:ext uri="{FF2B5EF4-FFF2-40B4-BE49-F238E27FC236}">
                <a16:creationId xmlns:a16="http://schemas.microsoft.com/office/drawing/2014/main" id="{7AC38742-B3CF-4EE6-9C4C-5455213FA1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416208" y="2025834"/>
            <a:ext cx="1013890" cy="1013890"/>
          </a:xfrm>
          <a:prstGeom prst="rect">
            <a:avLst/>
          </a:prstGeom>
        </p:spPr>
      </p:pic>
      <p:pic>
        <p:nvPicPr>
          <p:cNvPr id="30" name="Graphic 29" descr="Arrow circle with solid fill">
            <a:extLst>
              <a:ext uri="{FF2B5EF4-FFF2-40B4-BE49-F238E27FC236}">
                <a16:creationId xmlns:a16="http://schemas.microsoft.com/office/drawing/2014/main" id="{C1BA0FA3-1707-415F-8F90-228B8278D5DB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6983546" y="2388484"/>
            <a:ext cx="651240" cy="65124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6D66528E-3381-41F1-8702-52628345F0E2}"/>
              </a:ext>
            </a:extLst>
          </p:cNvPr>
          <p:cNvSpPr txBox="1"/>
          <p:nvPr/>
        </p:nvSpPr>
        <p:spPr>
          <a:xfrm>
            <a:off x="6505844" y="1684280"/>
            <a:ext cx="12704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100" dirty="0"/>
              <a:t>Age at kidney transplant</a:t>
            </a:r>
            <a:endParaRPr lang="zh-HK" altLang="en-US" sz="11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2D9641A-6388-4B68-963A-1BF35E8FC880}"/>
              </a:ext>
            </a:extLst>
          </p:cNvPr>
          <p:cNvSpPr txBox="1"/>
          <p:nvPr/>
        </p:nvSpPr>
        <p:spPr>
          <a:xfrm>
            <a:off x="7994937" y="1720477"/>
            <a:ext cx="12704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100" dirty="0"/>
              <a:t>Follow up Period</a:t>
            </a:r>
            <a:endParaRPr lang="zh-HK" altLang="en-US" sz="11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F21400C-B4A0-4894-A74D-86BC03B35042}"/>
              </a:ext>
            </a:extLst>
          </p:cNvPr>
          <p:cNvSpPr txBox="1"/>
          <p:nvPr/>
        </p:nvSpPr>
        <p:spPr>
          <a:xfrm>
            <a:off x="9449087" y="1713987"/>
            <a:ext cx="12704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100" dirty="0"/>
              <a:t>Patient survival</a:t>
            </a:r>
            <a:endParaRPr lang="zh-HK" altLang="en-US" sz="11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9D8425F-3F55-4899-A45A-25AB9198333E}"/>
              </a:ext>
            </a:extLst>
          </p:cNvPr>
          <p:cNvSpPr txBox="1"/>
          <p:nvPr/>
        </p:nvSpPr>
        <p:spPr>
          <a:xfrm>
            <a:off x="10941314" y="1733786"/>
            <a:ext cx="127041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1100" dirty="0"/>
              <a:t>Death censored graft survival</a:t>
            </a:r>
            <a:endParaRPr lang="zh-HK" altLang="en-US" sz="11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734A015-3552-4DBC-899F-A25245D0A6AC}"/>
              </a:ext>
            </a:extLst>
          </p:cNvPr>
          <p:cNvSpPr txBox="1"/>
          <p:nvPr/>
        </p:nvSpPr>
        <p:spPr>
          <a:xfrm>
            <a:off x="6630994" y="4365293"/>
            <a:ext cx="12704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6-13</a:t>
            </a:r>
          </a:p>
          <a:p>
            <a:r>
              <a:rPr lang="en-US" altLang="zh-HK" dirty="0"/>
              <a:t>Median 10.5</a:t>
            </a:r>
            <a:endParaRPr lang="zh-HK" altLang="en-US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5AC7DA58-D159-4834-8039-F74911A00231}"/>
              </a:ext>
            </a:extLst>
          </p:cNvPr>
          <p:cNvSpPr txBox="1"/>
          <p:nvPr/>
        </p:nvSpPr>
        <p:spPr>
          <a:xfrm>
            <a:off x="6525556" y="3201200"/>
            <a:ext cx="12704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4-59</a:t>
            </a:r>
          </a:p>
          <a:p>
            <a:r>
              <a:rPr lang="en-US" altLang="zh-HK" dirty="0"/>
              <a:t>Median 37</a:t>
            </a:r>
            <a:endParaRPr lang="zh-HK" altLang="en-US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E8A360F-D38D-4583-B2CB-4BC585DB16D9}"/>
              </a:ext>
            </a:extLst>
          </p:cNvPr>
          <p:cNvSpPr txBox="1"/>
          <p:nvPr/>
        </p:nvSpPr>
        <p:spPr>
          <a:xfrm>
            <a:off x="11060937" y="4499934"/>
            <a:ext cx="1270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2000" dirty="0"/>
              <a:t>90%</a:t>
            </a:r>
            <a:endParaRPr lang="zh-HK" altLang="en-US" sz="20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590AA8C-9C3F-4A08-93DF-291D2EEE10CC}"/>
              </a:ext>
            </a:extLst>
          </p:cNvPr>
          <p:cNvSpPr txBox="1"/>
          <p:nvPr/>
        </p:nvSpPr>
        <p:spPr>
          <a:xfrm>
            <a:off x="11036626" y="3331488"/>
            <a:ext cx="1270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2000" dirty="0"/>
              <a:t>96.7%</a:t>
            </a:r>
            <a:endParaRPr lang="zh-HK" altLang="en-US" sz="2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7996012-FED4-4DA4-9BCD-4D0A5FD228FE}"/>
              </a:ext>
            </a:extLst>
          </p:cNvPr>
          <p:cNvSpPr txBox="1"/>
          <p:nvPr/>
        </p:nvSpPr>
        <p:spPr>
          <a:xfrm>
            <a:off x="9720680" y="4503933"/>
            <a:ext cx="1270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2000" dirty="0"/>
              <a:t>90%</a:t>
            </a:r>
            <a:endParaRPr lang="zh-HK" altLang="en-US" sz="2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1953C6F-2910-49B3-B861-4CEA182E4222}"/>
              </a:ext>
            </a:extLst>
          </p:cNvPr>
          <p:cNvSpPr txBox="1"/>
          <p:nvPr/>
        </p:nvSpPr>
        <p:spPr>
          <a:xfrm>
            <a:off x="9598452" y="3316733"/>
            <a:ext cx="12704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sz="2000" dirty="0"/>
              <a:t>96.8%</a:t>
            </a:r>
            <a:endParaRPr lang="zh-HK" altLang="en-US" sz="20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F515026-1FCC-4443-9A77-A340A248E391}"/>
              </a:ext>
            </a:extLst>
          </p:cNvPr>
          <p:cNvSpPr txBox="1"/>
          <p:nvPr/>
        </p:nvSpPr>
        <p:spPr>
          <a:xfrm>
            <a:off x="7981399" y="3210357"/>
            <a:ext cx="12704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0.5-22</a:t>
            </a:r>
          </a:p>
          <a:p>
            <a:r>
              <a:rPr lang="en-US" altLang="zh-HK" dirty="0"/>
              <a:t>Median 5</a:t>
            </a:r>
            <a:endParaRPr lang="zh-HK" altLang="en-US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68C7EEB-37A5-43B1-8C9B-A912A469AE60}"/>
              </a:ext>
            </a:extLst>
          </p:cNvPr>
          <p:cNvSpPr txBox="1"/>
          <p:nvPr/>
        </p:nvSpPr>
        <p:spPr>
          <a:xfrm>
            <a:off x="8048178" y="4373646"/>
            <a:ext cx="12704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HK" dirty="0"/>
              <a:t>0.5-30</a:t>
            </a:r>
          </a:p>
          <a:p>
            <a:r>
              <a:rPr lang="en-US" altLang="zh-HK" dirty="0"/>
              <a:t>Median 3</a:t>
            </a:r>
            <a:endParaRPr lang="zh-HK" altLang="en-US" dirty="0"/>
          </a:p>
        </p:txBody>
      </p:sp>
    </p:spTree>
    <p:extLst>
      <p:ext uri="{BB962C8B-B14F-4D97-AF65-F5344CB8AC3E}">
        <p14:creationId xmlns:p14="http://schemas.microsoft.com/office/powerpoint/2010/main" val="950205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55</TotalTime>
  <Words>152</Words>
  <Application>Microsoft Office PowerPoint</Application>
  <PresentationFormat>Widescreen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8</cp:revision>
  <dcterms:created xsi:type="dcterms:W3CDTF">2019-06-13T12:30:18Z</dcterms:created>
  <dcterms:modified xsi:type="dcterms:W3CDTF">2025-10-15T12:26:50Z</dcterms:modified>
</cp:coreProperties>
</file>